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64" r:id="rId4"/>
    <p:sldId id="260" r:id="rId5"/>
    <p:sldId id="261" r:id="rId6"/>
    <p:sldId id="263" r:id="rId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5189" autoAdjust="0"/>
  </p:normalViewPr>
  <p:slideViewPr>
    <p:cSldViewPr snapToGrid="0">
      <p:cViewPr varScale="1">
        <p:scale>
          <a:sx n="57" d="100"/>
          <a:sy n="57" d="100"/>
        </p:scale>
        <p:origin x="82" y="4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7FF3CF-5139-4E27-A1BD-2F5A9E1CD1D4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7231E3-108F-4F44-8B21-7AF440E338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91663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 Traffic light plot for risk of bias in individual studies</a:t>
            </a:r>
          </a:p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rentheses indicate the journal in which the study was published.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For the overall risk of bias, low risk of bias required random sequencing, allocation concealment, and blinding in order to be scored low risk with no other important concerns; unclear risk of bias was assigned if 1 or 2 domains were scored not clear or not done; high risk of bias was assigned if &gt;2 domains were scored not clear or not done. 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231E3-108F-4F44-8B21-7AF440E338C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59936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.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est plot for ALT normalization after carnitine-</a:t>
            </a:r>
            <a:r>
              <a:rPr lang="en-US" altLang="ko-KR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otate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ersus control treatment according to dosage (900 mg vs. 600 mg).</a:t>
            </a:r>
            <a:endParaRPr lang="ko-KR" altLang="ko-KR" sz="1200" kern="120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ko-KR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T, alanine aminotransferase; CI, confidence interval; df, degrees of freedom; M-H, Mantel-Haenszel</a:t>
            </a:r>
            <a:endParaRPr lang="ko-KR" altLang="ko-KR" sz="1200" kern="120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231E3-108F-4F44-8B21-7AF440E338CE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474158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. Analysis of publication bias.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sing Egger’s test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altLang="ko-KR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Post-treatment AST level: </a:t>
            </a:r>
            <a:r>
              <a:rPr lang="en-US" altLang="ko-KR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value 0.2498, </a:t>
            </a:r>
            <a:r>
              <a:rPr lang="en-US" altLang="ko-KR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Post-treatment ALT level: </a:t>
            </a:r>
            <a:r>
              <a:rPr lang="en-US" altLang="ko-KR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value</a:t>
            </a:r>
            <a:r>
              <a:rPr lang="en-US" altLang="ko-KR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.5642)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AS-Thompson's test (</a:t>
            </a:r>
            <a:r>
              <a:rPr lang="en-US" altLang="ko-KR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Post-treatment AST level: </a:t>
            </a:r>
            <a:r>
              <a:rPr lang="en-US" altLang="ko-KR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value 0.3925, </a:t>
            </a:r>
            <a:r>
              <a:rPr lang="en-US" altLang="ko-KR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Post-treatment ALT level: </a:t>
            </a:r>
            <a:r>
              <a:rPr lang="en-US" altLang="ko-KR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altLang="ko-KR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value 0.675)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 publication bias, no significant asymmetry is seen in the funnel plot and radial plot (P &gt; 0.1) for pooled analysis of mean difference. 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7231E3-108F-4F44-8B21-7AF440E338CE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235901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. Sensitivity analysis of effect of </a:t>
            </a:r>
            <a:r>
              <a:rPr lang="en-US" altLang="ko-KR" sz="1200" b="1" kern="1200" cap="small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carnitine (or acetyl-</a:t>
            </a:r>
            <a:r>
              <a:rPr lang="en-US" altLang="ko-KR" sz="1200" b="1" kern="1200" cap="small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carnitine) supplementation on post-treatment AST and ALT level after the exclusion of a study of patients with decompensated cirrhosis [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1].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rentheses following the first author’s name indicate the journal in which the study was published.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Multiple doses were investigated in this study. Data from the maximal dosage group (3 g/day) were used in the analysis. 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T, alanine aminotransferase; AST, aspartate aminotransferase; CI, confidence interval;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f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degrees of freedom; IV, inverse variance; SD, standard deviation </a:t>
            </a:r>
            <a:endParaRPr lang="ko-KR" altLang="ko-K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231E3-108F-4F44-8B21-7AF440E338CE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232093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5. Sensitivity analysis of effect of </a:t>
            </a:r>
            <a:r>
              <a:rPr lang="en-US" altLang="ko-KR" sz="1200" b="1" kern="1200" cap="small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carnitine (or acetyl-</a:t>
            </a:r>
            <a:r>
              <a:rPr lang="en-US" altLang="ko-KR" sz="1200" b="1" kern="1200" cap="small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carnitine) supplementation on post-treatment AST and ALT level after the exclusion of four studies showing different baseline AST or ALT levels between treatment and control groups [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6,31,32,34].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rentheses following the first author’s name indicate the journal in which the study was published.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T, alanine aminotransferase; AST, aspartate aminotransferase; CI, confidence interval;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f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degrees of freedom; IV, inverse variance; SD, standard deviation </a:t>
            </a:r>
            <a:endParaRPr lang="ko-KR" altLang="ko-K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7231E3-108F-4F44-8B21-7AF440E338CE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587678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6. Sensitivity analysis of effect of </a:t>
            </a:r>
            <a:r>
              <a:rPr lang="en-US" altLang="ko-KR" sz="1200" b="1" kern="1200" cap="small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carnitine (or acetyl-</a:t>
            </a:r>
            <a:r>
              <a:rPr lang="en-US" altLang="ko-KR" sz="1200" b="1" kern="1200" cap="small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carnitine) supplementation on post-treatment AST and ALT level with jackknife sensitivity analysis showing the robustness</a:t>
            </a:r>
            <a:r>
              <a:rPr lang="en-US" altLang="ko-KR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meta-analysis.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rentheses following the first author’s name indicate the journal in which the study was published.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T, alanine aminotransferase; AST, aspartate aminotransferase; CI, confidence interval 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7231E3-108F-4F44-8B21-7AF440E338CE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64276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597210F-5DAE-E881-03CD-E8BD74911A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75560816-9CEF-1569-3E1B-FE317D0F90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463E3CF-5628-447A-F24A-EB793F81E3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2CD6C-6903-4073-BE03-EF433C18302B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2553F5C-9395-4471-3569-2CD907DFC0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E4CC618-B23C-AEB5-7F8C-169A9E7B0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C8401-0DB0-44AC-A6AC-A2192B3F8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0062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D2D5F70-D147-1F64-7014-56AA54B444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0EBF53B-43A9-9944-3E7A-6D235BD879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B830848-1733-C70F-F841-6FFAC6E1A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2CD6C-6903-4073-BE03-EF433C18302B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5CD2271-F809-B148-ACC0-FCC7C3241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DF67A4C-886A-827E-94AD-AC60A5A7D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C8401-0DB0-44AC-A6AC-A2192B3F8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3657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226BC16-4806-C178-A73A-78ACE506B5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B0B68F3-D920-4924-451C-B40C926FC1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A2EF42-C6BC-2C48-AA8E-EAA48E6F3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2CD6C-6903-4073-BE03-EF433C18302B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BFCDEF2-32D5-9312-3891-9A4ED0D5B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F981E15-60E9-90DB-8773-603455B6D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C8401-0DB0-44AC-A6AC-A2192B3F8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9806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76C9F1C-74B6-133C-291E-5138726CCD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9E32AAE-2258-8A52-D5E8-7A0C706952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4577256-4481-962F-1DEF-6691570F75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2CD6C-6903-4073-BE03-EF433C18302B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E5CB8F1-D994-0320-B3C6-4817B95CB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1D6F1D2-A007-CF3B-AAA8-F49798060E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C8401-0DB0-44AC-A6AC-A2192B3F8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3063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1952F6-610B-C3B0-0FC4-F088F35773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BAC5F6B-94AB-A84B-41D2-679A263E49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1535565-906E-F4AD-BA53-9BFE65AEDB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2CD6C-6903-4073-BE03-EF433C18302B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01AB82B-46E6-5662-151F-915D4FDF82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D1927CC-1CD4-15A9-57AF-514D676ADB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C8401-0DB0-44AC-A6AC-A2192B3F8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9644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47F770A-7218-EEA0-4CC3-A7A50396A4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E55DBC1-961C-9417-DD52-C4BAB33FA1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84A0291-05A3-6FAD-4677-84A2265BDF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EA52ABF-AE52-61D0-2DF8-280395B44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2CD6C-6903-4073-BE03-EF433C18302B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394F401-8E2E-1831-79A5-7E30ABB06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F4E568F-5109-B158-12EE-13A02461E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C8401-0DB0-44AC-A6AC-A2192B3F8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5955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694A89F-522F-261B-14C7-429BCEC726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A9B628F-02DE-08F2-2C1B-43B7439D23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95E9686-90FA-DA72-27BF-D9F3F6D077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E30156A1-4219-2AA3-654A-C9C6FF8B936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EDF03F47-A33C-1C23-8CA3-C773A01EB3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EBB0F664-EFB3-5B05-5A8C-03F65F6A6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2CD6C-6903-4073-BE03-EF433C18302B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BC3EC716-B22B-8EE4-E0C5-DC0C2D429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63055C80-D38B-46FC-C65A-70F7C91D2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C8401-0DB0-44AC-A6AC-A2192B3F8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4983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4055CD4-7B40-D55C-7D49-568A04A279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67527E4-269C-3D3E-B713-4013273C8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2CD6C-6903-4073-BE03-EF433C18302B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3EE8602C-17BC-C751-9F09-AA4CAB265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C088E54E-0F79-898A-B321-5D8B3E468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C8401-0DB0-44AC-A6AC-A2192B3F8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7912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75760A77-F673-6134-DC30-D75C4BC588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2CD6C-6903-4073-BE03-EF433C18302B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5BFD8A4-4083-1856-B7BE-93955DFD0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B4780F7-FAD2-78D5-CF62-F304C95EF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C8401-0DB0-44AC-A6AC-A2192B3F8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9978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582DA8A-BD43-2E81-2427-F5C76BDC9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72E9A25-14B8-2201-126D-AF03FD7301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397E3AF-1E24-35FF-63F3-AC923529B6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D468CCA-3270-365B-E5FE-4A1949BBF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2CD6C-6903-4073-BE03-EF433C18302B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CB9D828-AA18-BA88-4030-BE5C1FB14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5F3DEF0-A10D-611C-B4F6-AEB1396C6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C8401-0DB0-44AC-A6AC-A2192B3F8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928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D9179AD-B0A0-3AA8-8B8C-2624D68E82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D888007-2DBD-BDE1-28AB-1BE1A1D0DF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D6057F8-C837-5252-599A-92EACD2353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328BE7A-7E3C-B6BE-6E8C-C7435C97D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42CD6C-6903-4073-BE03-EF433C18302B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AEB2E50-F953-4918-33FB-9EF2443F2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A17D49B-A914-DB7B-B3CF-E56F17FF46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C8401-0DB0-44AC-A6AC-A2192B3F8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8126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922DA91-1E6E-42EC-58B0-7C1F76842F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0C3BE7B-1876-4DC6-10B3-065D6BB0C6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32D7DBB-6D57-A965-C595-68C294E1CC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42CD6C-6903-4073-BE03-EF433C18302B}" type="datetimeFigureOut">
              <a:rPr lang="ko-KR" altLang="en-US" smtClean="0"/>
              <a:t>2022-06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6C68987-37E6-6AC2-84EB-3415FB3335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9F4780A-DA46-18AA-15BD-CFA1FE5BC8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C8401-0DB0-44AC-A6AC-A2192B3F8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747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199" y="-1"/>
            <a:ext cx="4584701" cy="67840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38323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B6B498B2-CDB8-7E04-F4B3-F56E66B93A9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89700" cy="55567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83344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직사각형 11"/>
          <p:cNvSpPr/>
          <p:nvPr/>
        </p:nvSpPr>
        <p:spPr>
          <a:xfrm>
            <a:off x="-795644" y="-838738"/>
            <a:ext cx="17201325" cy="146167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857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8207" y="0"/>
            <a:ext cx="7570942" cy="7026596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83797" y="0"/>
            <a:ext cx="7566405" cy="699030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194242" y="-481819"/>
            <a:ext cx="3070649" cy="3854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ko-KR" sz="1905" b="1" dirty="0">
                <a:latin typeface="Arial" panose="020B0604020202020204" pitchFamily="34" charset="0"/>
                <a:cs typeface="Arial" panose="020B0604020202020204" pitchFamily="34" charset="0"/>
              </a:rPr>
              <a:t>Post-treatment AST level</a:t>
            </a:r>
            <a:endParaRPr lang="ko-KR" altLang="en-US" sz="190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9165883" y="-481819"/>
            <a:ext cx="3038076" cy="3854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ko-KR" sz="1905" b="1" dirty="0">
                <a:latin typeface="Arial" panose="020B0604020202020204" pitchFamily="34" charset="0"/>
                <a:cs typeface="Arial" panose="020B0604020202020204" pitchFamily="34" charset="0"/>
              </a:rPr>
              <a:t>Post-treatment ALT level</a:t>
            </a:r>
            <a:endParaRPr lang="ko-KR" altLang="en-US" sz="190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7801" y="7997498"/>
            <a:ext cx="7371348" cy="5543254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96999" y="7997498"/>
            <a:ext cx="7353203" cy="550242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194242" y="7495502"/>
            <a:ext cx="3070649" cy="3854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ko-KR" sz="1905" b="1" dirty="0">
                <a:latin typeface="Arial" panose="020B0604020202020204" pitchFamily="34" charset="0"/>
                <a:cs typeface="Arial" panose="020B0604020202020204" pitchFamily="34" charset="0"/>
              </a:rPr>
              <a:t>Post-treatment AST level</a:t>
            </a:r>
            <a:endParaRPr lang="ko-KR" altLang="en-US" sz="190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165883" y="7495502"/>
            <a:ext cx="3038076" cy="3854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ko-KR" sz="1905" b="1" dirty="0">
                <a:latin typeface="Arial" panose="020B0604020202020204" pitchFamily="34" charset="0"/>
                <a:cs typeface="Arial" panose="020B0604020202020204" pitchFamily="34" charset="0"/>
              </a:rPr>
              <a:t>Post-treatment ALT level</a:t>
            </a:r>
            <a:endParaRPr lang="ko-KR" altLang="en-US" sz="190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-787564" y="-597045"/>
            <a:ext cx="449162" cy="5320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57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85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-787564" y="7470600"/>
            <a:ext cx="449162" cy="5320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57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85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13366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D2E019F6-DC8E-CA42-3811-EF207482517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" y="-1"/>
            <a:ext cx="12192001" cy="65335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54219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196E8F04-E978-DBF4-5C56-B86223BFB38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-1"/>
            <a:ext cx="12188147" cy="5334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87965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/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777627" cy="6858000"/>
          </a:xfrm>
        </p:spPr>
      </p:pic>
    </p:spTree>
    <p:extLst>
      <p:ext uri="{BB962C8B-B14F-4D97-AF65-F5344CB8AC3E}">
        <p14:creationId xmlns:p14="http://schemas.microsoft.com/office/powerpoint/2010/main" val="25062175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</TotalTime>
  <Words>482</Words>
  <Application>Microsoft Office PowerPoint</Application>
  <PresentationFormat>와이드스크린</PresentationFormat>
  <Paragraphs>28</Paragraphs>
  <Slides>6</Slides>
  <Notes>6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9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OHW</dc:creator>
  <cp:lastModifiedBy>Oh Hyunwoo</cp:lastModifiedBy>
  <cp:revision>14</cp:revision>
  <dcterms:created xsi:type="dcterms:W3CDTF">2022-05-12T19:28:15Z</dcterms:created>
  <dcterms:modified xsi:type="dcterms:W3CDTF">2022-06-27T09:15:17Z</dcterms:modified>
</cp:coreProperties>
</file>